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4587" autoAdjust="0"/>
    <p:restoredTop sz="86387" autoAdjust="0"/>
  </p:normalViewPr>
  <p:slideViewPr>
    <p:cSldViewPr snapToGrid="0">
      <p:cViewPr varScale="1">
        <p:scale>
          <a:sx n="59" d="100"/>
          <a:sy n="59" d="100"/>
        </p:scale>
        <p:origin x="212" y="60"/>
      </p:cViewPr>
      <p:guideLst/>
    </p:cSldViewPr>
  </p:slideViewPr>
  <p:outlineViewPr>
    <p:cViewPr>
      <p:scale>
        <a:sx n="33" d="100"/>
        <a:sy n="33" d="100"/>
      </p:scale>
      <p:origin x="0" y="0"/>
    </p:cViewPr>
    <p:sldLst>
      <p:sld r:id="rId1" collapse="1"/>
    </p:sldLst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_rels/viewProps.xml.rels><?xml version="1.0" encoding="UTF-8" standalone="yes"?>
<Relationships xmlns="http://schemas.openxmlformats.org/package/2006/relationships"><Relationship Id="rId1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949113-3711-4C8B-A84D-0C67DD04152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0E856D3-5F7D-49CA-AC14-14A34A10B81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588A13-C38D-48A6-B193-DBA9C7AE50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6AE30-E651-49C2-B32E-08077CC8227D}" type="datetimeFigureOut">
              <a:rPr lang="en-US" smtClean="0"/>
              <a:t>1/18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929022-A110-4151-8A9A-C371FB335C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8DB9B9-5189-4551-BB9F-8B871F6D38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21E08-459D-4BC8-9B81-0DEF8B168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73548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1114DA-EBA2-4D9C-B19C-AF2E50ADA4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37A524C-FC75-41FF-81C5-295CAA3651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BF0E51-5F6E-42EF-9E58-ABCA58EA60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6AE30-E651-49C2-B32E-08077CC8227D}" type="datetimeFigureOut">
              <a:rPr lang="en-US" smtClean="0"/>
              <a:t>1/18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2B137D-6B23-4044-A9B0-39D1A79BCF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4FF7CE-F752-4481-8674-78CF9E4151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21E08-459D-4BC8-9B81-0DEF8B168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69915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E093E62-2ACD-4515-A4A6-C7A8183B096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D3A3386-D54D-4949-A158-5CEB1FA4C88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E13EBC-DF7B-49A7-8A68-485F3B02C1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6AE30-E651-49C2-B32E-08077CC8227D}" type="datetimeFigureOut">
              <a:rPr lang="en-US" smtClean="0"/>
              <a:t>1/18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89B785-DBFE-4030-8ADE-4B32DF5EB4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DB7D3D-22E9-41E5-9009-1ADF113319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21E08-459D-4BC8-9B81-0DEF8B168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6656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9751D8-77D9-426E-877D-53358A1766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FF07F1-AFD7-4D76-A807-BD9AE5DEB08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80461A-2B68-4886-964C-5357299190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6AE30-E651-49C2-B32E-08077CC8227D}" type="datetimeFigureOut">
              <a:rPr lang="en-US" smtClean="0"/>
              <a:t>1/18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03E641-8ECB-4100-91EE-E18C94B956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9AF400-6436-49B0-93B0-C4AF84465F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21E08-459D-4BC8-9B81-0DEF8B168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52132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4C52C9-FC64-4EB9-BF5D-81FCB47BEE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FC1A58-8595-49A8-A143-D639482ADF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B5F173-CC09-4E39-BEAE-CB8410E890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6AE30-E651-49C2-B32E-08077CC8227D}" type="datetimeFigureOut">
              <a:rPr lang="en-US" smtClean="0"/>
              <a:t>1/18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78DE0F-0A93-446D-8F65-3915547612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C79770-FCF5-46C8-A7CB-8711C4F2D7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21E08-459D-4BC8-9B81-0DEF8B168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9292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C27EA6-A7F7-4D96-BBAD-F297AFE733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C1B470-45C4-431B-A6F4-8F7633DCF1D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0F3A10C-527F-4C2D-B5A1-58F8737679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1F9E0C2-C66C-4602-B964-E166EDDE91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6AE30-E651-49C2-B32E-08077CC8227D}" type="datetimeFigureOut">
              <a:rPr lang="en-US" smtClean="0"/>
              <a:t>1/18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A008443-8896-4D96-ABA4-68D9E9E536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3D5B8C-0D4D-4A8D-9874-88A30C92DA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21E08-459D-4BC8-9B81-0DEF8B168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89836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E13D58-658E-4028-9ED8-A414C5F544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D8F8B62-7A7F-4644-8CB0-F5F1E544C5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40D4EB8-3191-4F42-AF8A-BCF4B0009A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E8CE45D-75E8-4A35-B007-AA7DB83804A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1C83635-6BE2-493E-AABD-0FCF80049C0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82DF402-49F6-44B6-B32F-F396EAC8A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6AE30-E651-49C2-B32E-08077CC8227D}" type="datetimeFigureOut">
              <a:rPr lang="en-US" smtClean="0"/>
              <a:t>1/18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8EBE0AD-65A7-42FD-8286-08B6DDC373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1735402-84AC-40E8-A7E7-2FD67AA625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21E08-459D-4BC8-9B81-0DEF8B168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2803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1A5EAF-C788-4910-A349-2C8ADC0108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56B0A5C-0896-4BEE-A90E-9FC78CD862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6AE30-E651-49C2-B32E-08077CC8227D}" type="datetimeFigureOut">
              <a:rPr lang="en-US" smtClean="0"/>
              <a:t>1/18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C3441C9-1DB1-4001-9983-C2A6EAEF62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E8E71DC-52C3-4221-AC18-F27C896606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21E08-459D-4BC8-9B81-0DEF8B168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42429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689FD32-AB33-4329-BA81-C25F6692AD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6AE30-E651-49C2-B32E-08077CC8227D}" type="datetimeFigureOut">
              <a:rPr lang="en-US" smtClean="0"/>
              <a:t>1/18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1C89272-D109-4C77-BD38-73ACD7716C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256D28A-03DA-4590-9A85-CC5EA89637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21E08-459D-4BC8-9B81-0DEF8B168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54581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4585AE-B7EB-4388-9D88-6F238E63D7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6AC7CC-778F-4AD0-B056-9114732B286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4558756-E42F-4B2B-8364-9FF7794570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D597A4-DFEB-4C44-ADD2-9B408EA6E1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6AE30-E651-49C2-B32E-08077CC8227D}" type="datetimeFigureOut">
              <a:rPr lang="en-US" smtClean="0"/>
              <a:t>1/18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999A0C-0A1F-467E-8BB0-B81F5D8C2C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B2EE51-D92C-4DE4-8968-15EEFD9B37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21E08-459D-4BC8-9B81-0DEF8B168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00441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EFA780-ED09-40F5-96F4-3A4BEA8674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77A3FCC-1ABC-42E1-BF74-30678CCF76D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A4FD8BA-185C-405E-B73B-65B68CF385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9E5F9B7-7640-4351-83A8-BEE1D41B59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6AE30-E651-49C2-B32E-08077CC8227D}" type="datetimeFigureOut">
              <a:rPr lang="en-US" smtClean="0"/>
              <a:t>1/18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6D4465-FA45-48A0-8937-C1C617F26C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6A052E8-5C9E-41A9-8A0F-AA817C9CAE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21E08-459D-4BC8-9B81-0DEF8B168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923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46E87BB-F4A6-4D88-853E-A22A963F2A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9749D2E-B06E-4CDE-9FA7-C85310C085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46AC9E-8884-403B-B8E7-1D8CD9B3C8A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16AE30-E651-49C2-B32E-08077CC8227D}" type="datetimeFigureOut">
              <a:rPr lang="en-US" smtClean="0"/>
              <a:t>1/18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ABCCC9-266A-456F-8A59-13463511C0B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B0B8A8-9759-4264-9FBD-2EAB4A34D3C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021E08-459D-4BC8-9B81-0DEF8B168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09586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EF289C2-048B-49C2-AC72-B62023E2B7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01820" y="94943"/>
            <a:ext cx="5363109" cy="536310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D97D8E9-4108-44B4-A718-5FF5BF446B41}"/>
              </a:ext>
            </a:extLst>
          </p:cNvPr>
          <p:cNvSpPr txBox="1"/>
          <p:nvPr/>
        </p:nvSpPr>
        <p:spPr>
          <a:xfrm>
            <a:off x="2901820" y="6055567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762CC665-4968-CA4F-963D-C3321DF47EEA}"/>
              </a:ext>
            </a:extLst>
          </p:cNvPr>
          <p:cNvSpPr/>
          <p:nvPr/>
        </p:nvSpPr>
        <p:spPr>
          <a:xfrm>
            <a:off x="513284" y="5458052"/>
            <a:ext cx="11165432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1 Fig. Visualization of the c</a:t>
            </a:r>
            <a:r>
              <a:rPr lang="en-US" sz="14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-expression </a:t>
            </a:r>
            <a:r>
              <a:rPr lang="en-US" sz="14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alysis of </a:t>
            </a:r>
            <a:r>
              <a:rPr lang="en-US" sz="1400" b="1" i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ZmSTs</a:t>
            </a:r>
            <a:r>
              <a:rPr lang="en-GB" sz="14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ere, </a:t>
            </a:r>
            <a:r>
              <a:rPr lang="en-US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91 genes were found to interact with 43 </a:t>
            </a:r>
            <a:r>
              <a:rPr lang="en-US" sz="1400" i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ZmSTs</a:t>
            </a:r>
            <a:r>
              <a:rPr lang="en-US" sz="1400" i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ere, red, yellow, green, sky-blue, and blue represent </a:t>
            </a:r>
            <a:r>
              <a:rPr lang="en-US" sz="14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henylpropanoid</a:t>
            </a:r>
            <a:r>
              <a:rPr lang="en-US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iosynthesis, </a:t>
            </a:r>
            <a:r>
              <a:rPr lang="en-US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arch </a:t>
            </a:r>
            <a:r>
              <a:rPr lang="en-US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sucrose metabolism, </a:t>
            </a:r>
            <a:r>
              <a:rPr lang="en-US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ant </a:t>
            </a:r>
            <a:r>
              <a:rPr lang="en-US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ormone signal </a:t>
            </a:r>
            <a:r>
              <a:rPr lang="en-US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ansduction, carbon metabolism, </a:t>
            </a:r>
            <a:r>
              <a:rPr lang="en-US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iosynthesis </a:t>
            </a:r>
            <a:r>
              <a:rPr lang="en-US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 amino </a:t>
            </a:r>
            <a:r>
              <a:rPr lang="en-US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ids, respectively.</a:t>
            </a:r>
            <a:endParaRPr lang="en-US" sz="14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81046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6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Lenovo T460s</cp:lastModifiedBy>
  <cp:revision>6</cp:revision>
  <dcterms:created xsi:type="dcterms:W3CDTF">2023-11-15T12:38:25Z</dcterms:created>
  <dcterms:modified xsi:type="dcterms:W3CDTF">2026-01-18T06:43:51Z</dcterms:modified>
</cp:coreProperties>
</file>